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18300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0DB237-D35F-4C9D-9463-05C8C78BC3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CF1B7C-9A3D-4E3F-BE5E-6EF51F8F67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676AE0-ABD9-4DB7-8A32-0423CB6001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706C31-B815-45A1-BE56-48658FCC6E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D40D27-37D8-4280-9590-787B54D6D5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C89B0-56B8-49F5-9C02-83061CE41E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2969A-D288-4B53-83BF-E434403729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08DE3-3E67-41C6-ACFA-260E2D5642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84DF8A-2E1F-472D-AA89-17F8B1E4F9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4708FA-B219-44DE-A870-08A515EC07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F37E6F-8217-440F-B782-33348F9326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0929C5-1D5F-44DD-9217-962D4734C4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F20C51-32D7-498E-A057-18AA474B9E51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72320" y="1197000"/>
            <a:ext cx="8203320" cy="2802240"/>
            <a:chOff x="472320" y="1197000"/>
            <a:chExt cx="8203320" cy="2802240"/>
          </a:xfrm>
        </p:grpSpPr>
        <p:sp>
          <p:nvSpPr>
            <p:cNvPr id="42" name=""/>
            <p:cNvSpPr/>
            <p:nvPr/>
          </p:nvSpPr>
          <p:spPr>
            <a:xfrm>
              <a:off x="2494440" y="1211400"/>
              <a:ext cx="50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rd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142080" y="1211400"/>
              <a:ext cx="511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rd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791160" y="1211400"/>
              <a:ext cx="511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rd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654800" y="1212840"/>
              <a:ext cx="50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rd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5304240" y="1222200"/>
              <a:ext cx="50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rd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6312240" y="1211400"/>
              <a:ext cx="50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rd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5807520" y="1211400"/>
              <a:ext cx="511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rd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6960600" y="1197000"/>
              <a:ext cx="49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rd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7680960" y="1197000"/>
              <a:ext cx="520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rd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75920" y="1341360"/>
              <a:ext cx="16466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Clostridium sticklandi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DSM51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72320" y="1844640"/>
              <a:ext cx="20142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Alkaliphilus metalliredigen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QIM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73760" y="2394000"/>
              <a:ext cx="169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Alkaliphilus oremlandi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OhILA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76640" y="2919240"/>
              <a:ext cx="14518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Clostridium diffici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63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75200" y="3403440"/>
              <a:ext cx="1648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Clostridium botulinu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A Hal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495520" y="1557360"/>
              <a:ext cx="431640" cy="142920"/>
            </a:xfrm>
            <a:prstGeom prst="rightArrow">
              <a:avLst>
                <a:gd name="adj1" fmla="val 50000"/>
                <a:gd name="adj2" fmla="val 75504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071880" y="1557360"/>
              <a:ext cx="647640" cy="142920"/>
            </a:xfrm>
            <a:prstGeom prst="rightArrow">
              <a:avLst>
                <a:gd name="adj1" fmla="val 50000"/>
                <a:gd name="adj2" fmla="val 113287"/>
              </a:avLst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862440" y="1557360"/>
              <a:ext cx="504720" cy="142920"/>
            </a:xfrm>
            <a:prstGeom prst="rightArrow">
              <a:avLst>
                <a:gd name="adj1" fmla="val 50000"/>
                <a:gd name="adj2" fmla="val 88287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511520" y="1557360"/>
              <a:ext cx="792360" cy="142920"/>
            </a:xfrm>
            <a:prstGeom prst="rightArrow">
              <a:avLst>
                <a:gd name="adj1" fmla="val 50000"/>
                <a:gd name="adj2" fmla="val 138602"/>
              </a:avLst>
            </a:prstGeom>
            <a:solidFill>
              <a:srgbClr val="ffcc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375160" y="1557360"/>
              <a:ext cx="360360" cy="142920"/>
            </a:xfrm>
            <a:prstGeom prst="rightArrow">
              <a:avLst>
                <a:gd name="adj1" fmla="val 50000"/>
                <a:gd name="adj2" fmla="val 63035"/>
              </a:avLst>
            </a:prstGeom>
            <a:solidFill>
              <a:srgbClr val="0099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879880" y="1557360"/>
              <a:ext cx="432000" cy="142920"/>
            </a:xfrm>
            <a:prstGeom prst="rightArrow">
              <a:avLst>
                <a:gd name="adj1" fmla="val 50000"/>
                <a:gd name="adj2" fmla="val 75567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438960" y="1557360"/>
              <a:ext cx="288720" cy="142920"/>
            </a:xfrm>
            <a:prstGeom prst="rightArrow">
              <a:avLst>
                <a:gd name="adj1" fmla="val 50000"/>
                <a:gd name="adj2" fmla="val 50504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6815160" y="1557360"/>
              <a:ext cx="792000" cy="142920"/>
            </a:xfrm>
            <a:prstGeom prst="rightArrow">
              <a:avLst>
                <a:gd name="adj1" fmla="val 50000"/>
                <a:gd name="adj2" fmla="val 138539"/>
              </a:avLst>
            </a:prstGeom>
            <a:solidFill>
              <a:srgbClr val="cc00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7680240" y="1557360"/>
              <a:ext cx="504720" cy="142920"/>
            </a:xfrm>
            <a:prstGeom prst="rightArrow">
              <a:avLst>
                <a:gd name="adj1" fmla="val 50000"/>
                <a:gd name="adj2" fmla="val 88287"/>
              </a:avLst>
            </a:prstGeom>
            <a:solidFill>
              <a:srgbClr val="6666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485800" y="2033640"/>
              <a:ext cx="647640" cy="142920"/>
            </a:xfrm>
            <a:prstGeom prst="rightArrow">
              <a:avLst>
                <a:gd name="adj1" fmla="val 50000"/>
                <a:gd name="adj2" fmla="val 113287"/>
              </a:avLst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205080" y="2033640"/>
              <a:ext cx="504720" cy="142920"/>
            </a:xfrm>
            <a:prstGeom prst="rightArrow">
              <a:avLst>
                <a:gd name="adj1" fmla="val 50000"/>
                <a:gd name="adj2" fmla="val 88287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797280" y="2033640"/>
              <a:ext cx="792000" cy="142920"/>
            </a:xfrm>
            <a:prstGeom prst="rightArrow">
              <a:avLst>
                <a:gd name="adj1" fmla="val 50000"/>
                <a:gd name="adj2" fmla="val 138539"/>
              </a:avLst>
            </a:prstGeom>
            <a:solidFill>
              <a:srgbClr val="ffcc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653000" y="2025720"/>
              <a:ext cx="360360" cy="142920"/>
            </a:xfrm>
            <a:prstGeom prst="rightArrow">
              <a:avLst>
                <a:gd name="adj1" fmla="val 50000"/>
                <a:gd name="adj2" fmla="val 63035"/>
              </a:avLst>
            </a:prstGeom>
            <a:solidFill>
              <a:srgbClr val="0099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076720" y="2033640"/>
              <a:ext cx="289080" cy="144360"/>
            </a:xfrm>
            <a:prstGeom prst="rightArrow">
              <a:avLst>
                <a:gd name="adj1" fmla="val 50000"/>
                <a:gd name="adj2" fmla="val 50062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560" bIns="25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5452920" y="2033640"/>
              <a:ext cx="432000" cy="142920"/>
            </a:xfrm>
            <a:prstGeom prst="rightArrow">
              <a:avLst>
                <a:gd name="adj1" fmla="val 50000"/>
                <a:gd name="adj2" fmla="val 75567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5973480" y="2033640"/>
              <a:ext cx="289080" cy="142920"/>
            </a:xfrm>
            <a:prstGeom prst="rightArrow">
              <a:avLst>
                <a:gd name="adj1" fmla="val 50000"/>
                <a:gd name="adj2" fmla="val 50567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6373800" y="2033640"/>
              <a:ext cx="792000" cy="142920"/>
            </a:xfrm>
            <a:prstGeom prst="rightArrow">
              <a:avLst>
                <a:gd name="adj1" fmla="val 50000"/>
                <a:gd name="adj2" fmla="val 138539"/>
              </a:avLst>
            </a:prstGeom>
            <a:solidFill>
              <a:srgbClr val="cc00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7237440" y="2033640"/>
              <a:ext cx="504720" cy="142920"/>
            </a:xfrm>
            <a:prstGeom prst="rightArrow">
              <a:avLst>
                <a:gd name="adj1" fmla="val 50000"/>
                <a:gd name="adj2" fmla="val 88287"/>
              </a:avLst>
            </a:prstGeom>
            <a:solidFill>
              <a:srgbClr val="6666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454120" y="2492280"/>
              <a:ext cx="647640" cy="142920"/>
            </a:xfrm>
            <a:prstGeom prst="rightArrow">
              <a:avLst>
                <a:gd name="adj1" fmla="val 50000"/>
                <a:gd name="adj2" fmla="val 113287"/>
              </a:avLst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213000" y="2492280"/>
              <a:ext cx="504720" cy="142920"/>
            </a:xfrm>
            <a:prstGeom prst="rightArrow">
              <a:avLst>
                <a:gd name="adj1" fmla="val 50000"/>
                <a:gd name="adj2" fmla="val 88287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838320" y="2476440"/>
              <a:ext cx="792360" cy="142920"/>
            </a:xfrm>
            <a:prstGeom prst="rightArrow">
              <a:avLst>
                <a:gd name="adj1" fmla="val 50000"/>
                <a:gd name="adj2" fmla="val 138602"/>
              </a:avLst>
            </a:prstGeom>
            <a:solidFill>
              <a:srgbClr val="ffcc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725720" y="2476440"/>
              <a:ext cx="360360" cy="142920"/>
            </a:xfrm>
            <a:prstGeom prst="rightArrow">
              <a:avLst>
                <a:gd name="adj1" fmla="val 50000"/>
                <a:gd name="adj2" fmla="val 63035"/>
              </a:avLst>
            </a:prstGeom>
            <a:solidFill>
              <a:srgbClr val="0099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190840" y="2484360"/>
              <a:ext cx="255600" cy="136440"/>
            </a:xfrm>
            <a:prstGeom prst="rightArrow">
              <a:avLst>
                <a:gd name="adj1" fmla="val 50000"/>
                <a:gd name="adj2" fmla="val 46834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1600" bIns="216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518080" y="2468520"/>
              <a:ext cx="431640" cy="142920"/>
            </a:xfrm>
            <a:prstGeom prst="rightArrow">
              <a:avLst>
                <a:gd name="adj1" fmla="val 50000"/>
                <a:gd name="adj2" fmla="val 75504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6037200" y="2468520"/>
              <a:ext cx="288720" cy="142920"/>
            </a:xfrm>
            <a:prstGeom prst="rightArrow">
              <a:avLst>
                <a:gd name="adj1" fmla="val 50000"/>
                <a:gd name="adj2" fmla="val 50504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6421320" y="2462040"/>
              <a:ext cx="792000" cy="142920"/>
            </a:xfrm>
            <a:prstGeom prst="rightArrow">
              <a:avLst>
                <a:gd name="adj1" fmla="val 50000"/>
                <a:gd name="adj2" fmla="val 138539"/>
              </a:avLst>
            </a:prstGeom>
            <a:solidFill>
              <a:srgbClr val="cc00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7302240" y="2460600"/>
              <a:ext cx="505080" cy="142920"/>
            </a:xfrm>
            <a:prstGeom prst="rightArrow">
              <a:avLst>
                <a:gd name="adj1" fmla="val 50000"/>
                <a:gd name="adj2" fmla="val 88350"/>
              </a:avLst>
            </a:prstGeom>
            <a:solidFill>
              <a:srgbClr val="6666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8170920" y="2965320"/>
              <a:ext cx="504720" cy="142920"/>
            </a:xfrm>
            <a:prstGeom prst="rightArrow">
              <a:avLst>
                <a:gd name="adj1" fmla="val 50000"/>
                <a:gd name="adj2" fmla="val 88287"/>
              </a:avLst>
            </a:prstGeom>
            <a:solidFill>
              <a:srgbClr val="6666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6527520" y="3494160"/>
              <a:ext cx="792360" cy="142920"/>
            </a:xfrm>
            <a:prstGeom prst="rightArrow">
              <a:avLst>
                <a:gd name="adj1" fmla="val 50000"/>
                <a:gd name="adj2" fmla="val 138602"/>
              </a:avLst>
            </a:prstGeom>
            <a:solidFill>
              <a:srgbClr val="cc00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6951600" y="2971800"/>
              <a:ext cx="288720" cy="142920"/>
            </a:xfrm>
            <a:prstGeom prst="rightArrow">
              <a:avLst>
                <a:gd name="adj1" fmla="val 50000"/>
                <a:gd name="adj2" fmla="val 50504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6603840" y="2978280"/>
              <a:ext cx="289080" cy="142920"/>
            </a:xfrm>
            <a:prstGeom prst="rightArrow">
              <a:avLst>
                <a:gd name="adj1" fmla="val 50000"/>
                <a:gd name="adj2" fmla="val 50567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6127560" y="2981160"/>
              <a:ext cx="432000" cy="142920"/>
            </a:xfrm>
            <a:prstGeom prst="rightArrow">
              <a:avLst>
                <a:gd name="adj1" fmla="val 50000"/>
                <a:gd name="adj2" fmla="val 75567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5367240" y="2984400"/>
              <a:ext cx="360360" cy="142920"/>
            </a:xfrm>
            <a:prstGeom prst="rightArrow">
              <a:avLst>
                <a:gd name="adj1" fmla="val 50000"/>
                <a:gd name="adj2" fmla="val 63035"/>
              </a:avLst>
            </a:prstGeom>
            <a:solidFill>
              <a:srgbClr val="0099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493720" y="2997360"/>
              <a:ext cx="505080" cy="142560"/>
            </a:xfrm>
            <a:prstGeom prst="rightArrow">
              <a:avLst>
                <a:gd name="adj1" fmla="val 50000"/>
                <a:gd name="adj2" fmla="val 88573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070080" y="2997360"/>
              <a:ext cx="647640" cy="144360"/>
            </a:xfrm>
            <a:prstGeom prst="rightArrow">
              <a:avLst>
                <a:gd name="adj1" fmla="val 50000"/>
                <a:gd name="adj2" fmla="val 112157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560" bIns="25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789360" y="2997360"/>
              <a:ext cx="647640" cy="142560"/>
            </a:xfrm>
            <a:prstGeom prst="rightArrow">
              <a:avLst>
                <a:gd name="adj1" fmla="val 50000"/>
                <a:gd name="adj2" fmla="val 113573"/>
              </a:avLst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491000" y="2990880"/>
              <a:ext cx="792000" cy="142920"/>
            </a:xfrm>
            <a:prstGeom prst="rightArrow">
              <a:avLst>
                <a:gd name="adj1" fmla="val 50000"/>
                <a:gd name="adj2" fmla="val 138539"/>
              </a:avLst>
            </a:prstGeom>
            <a:solidFill>
              <a:srgbClr val="ffcc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5805360" y="2984400"/>
              <a:ext cx="255600" cy="136800"/>
            </a:xfrm>
            <a:prstGeom prst="rightArrow">
              <a:avLst>
                <a:gd name="adj1" fmla="val 50000"/>
                <a:gd name="adj2" fmla="val 46711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1600" bIns="216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7319880" y="2970360"/>
              <a:ext cx="792000" cy="142560"/>
            </a:xfrm>
            <a:prstGeom prst="rightArrow">
              <a:avLst>
                <a:gd name="adj1" fmla="val 50000"/>
                <a:gd name="adj2" fmla="val 138889"/>
              </a:avLst>
            </a:prstGeom>
            <a:solidFill>
              <a:srgbClr val="cc00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493720" y="3500280"/>
              <a:ext cx="505080" cy="142920"/>
            </a:xfrm>
            <a:prstGeom prst="rightArrow">
              <a:avLst>
                <a:gd name="adj1" fmla="val 50000"/>
                <a:gd name="adj2" fmla="val 88350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070080" y="3500280"/>
              <a:ext cx="360360" cy="144720"/>
            </a:xfrm>
            <a:prstGeom prst="rightArrow">
              <a:avLst>
                <a:gd name="adj1" fmla="val 50000"/>
                <a:gd name="adj2" fmla="val 62251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920" bIns="259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463920" y="3500280"/>
              <a:ext cx="255600" cy="136800"/>
            </a:xfrm>
            <a:prstGeom prst="rightArrow">
              <a:avLst>
                <a:gd name="adj1" fmla="val 50000"/>
                <a:gd name="adj2" fmla="val 46711"/>
              </a:avLst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1600" bIns="216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790800" y="3500280"/>
              <a:ext cx="504720" cy="142920"/>
            </a:xfrm>
            <a:prstGeom prst="rightArrow">
              <a:avLst>
                <a:gd name="adj1" fmla="val 50000"/>
                <a:gd name="adj2" fmla="val 88287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367160" y="3500280"/>
              <a:ext cx="792000" cy="142920"/>
            </a:xfrm>
            <a:prstGeom prst="rightArrow">
              <a:avLst>
                <a:gd name="adj1" fmla="val 50000"/>
                <a:gd name="adj2" fmla="val 138539"/>
              </a:avLst>
            </a:prstGeom>
            <a:solidFill>
              <a:srgbClr val="ffcc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5230800" y="3500280"/>
              <a:ext cx="360360" cy="142920"/>
            </a:xfrm>
            <a:prstGeom prst="rightArrow">
              <a:avLst>
                <a:gd name="adj1" fmla="val 50000"/>
                <a:gd name="adj2" fmla="val 63035"/>
              </a:avLst>
            </a:prstGeom>
            <a:solidFill>
              <a:srgbClr val="0099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5662440" y="3500280"/>
              <a:ext cx="432000" cy="142920"/>
            </a:xfrm>
            <a:prstGeom prst="rightArrow">
              <a:avLst>
                <a:gd name="adj1" fmla="val 50000"/>
                <a:gd name="adj2" fmla="val 75567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6161040" y="3494160"/>
              <a:ext cx="288720" cy="142920"/>
            </a:xfrm>
            <a:prstGeom prst="rightArrow">
              <a:avLst>
                <a:gd name="adj1" fmla="val 50000"/>
                <a:gd name="adj2" fmla="val 50504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7391160" y="3500280"/>
              <a:ext cx="505080" cy="142920"/>
            </a:xfrm>
            <a:prstGeom prst="rightArrow">
              <a:avLst>
                <a:gd name="adj1" fmla="val 50000"/>
                <a:gd name="adj2" fmla="val 88350"/>
              </a:avLst>
            </a:prstGeom>
            <a:solidFill>
              <a:srgbClr val="6666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493720" y="3789360"/>
              <a:ext cx="505080" cy="142920"/>
            </a:xfrm>
            <a:prstGeom prst="rightArrow">
              <a:avLst>
                <a:gd name="adj1" fmla="val 50000"/>
                <a:gd name="adj2" fmla="val 88350"/>
              </a:avLst>
            </a:prstGeom>
            <a:solidFill>
              <a:srgbClr val="6666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070080" y="3789360"/>
              <a:ext cx="504720" cy="142920"/>
            </a:xfrm>
            <a:prstGeom prst="rightArrow">
              <a:avLst>
                <a:gd name="adj1" fmla="val 50000"/>
                <a:gd name="adj2" fmla="val 88287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646440" y="3789360"/>
              <a:ext cx="792000" cy="142920"/>
            </a:xfrm>
            <a:prstGeom prst="rightArrow">
              <a:avLst>
                <a:gd name="adj1" fmla="val 50000"/>
                <a:gd name="adj2" fmla="val 138539"/>
              </a:avLst>
            </a:prstGeom>
            <a:solidFill>
              <a:srgbClr val="ffcc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510080" y="3782880"/>
              <a:ext cx="360360" cy="142920"/>
            </a:xfrm>
            <a:prstGeom prst="rightArrow">
              <a:avLst>
                <a:gd name="adj1" fmla="val 50000"/>
                <a:gd name="adj2" fmla="val 63035"/>
              </a:avLst>
            </a:prstGeom>
            <a:solidFill>
              <a:srgbClr val="0099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943520" y="3789360"/>
              <a:ext cx="255600" cy="136440"/>
            </a:xfrm>
            <a:prstGeom prst="rightArrow">
              <a:avLst>
                <a:gd name="adj1" fmla="val 50000"/>
                <a:gd name="adj2" fmla="val 46834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1600" bIns="216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302080" y="3789360"/>
              <a:ext cx="504720" cy="142920"/>
            </a:xfrm>
            <a:prstGeom prst="rightArrow">
              <a:avLst>
                <a:gd name="adj1" fmla="val 50000"/>
                <a:gd name="adj2" fmla="val 88287"/>
              </a:avLst>
            </a:prstGeom>
            <a:solidFill>
              <a:srgbClr val="6666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3287520" y="196056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3927240" y="148428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287520" y="242100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643280" y="195732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728960" y="240840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5376600" y="148428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5364000" y="291132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5232240" y="342900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2555640" y="342900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863880" y="342900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125520" y="372276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511520" y="371628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30T14:51:23Z</dcterms:created>
  <dc:creator>Default</dc:creator>
  <dc:description/>
  <dc:language>en-US</dc:language>
  <cp:lastModifiedBy>fonk</cp:lastModifiedBy>
  <dcterms:modified xsi:type="dcterms:W3CDTF">2010-09-07T13:09:41Z</dcterms:modified>
  <cp:revision>18</cp:revision>
  <dc:subject/>
  <dc:title>Diapositive 1</dc:title>
</cp:coreProperties>
</file>